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9906000" cy="6858000" type="A4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640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260" y="96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50D8D0-1EA8-7646-BD85-F1C3ED78C2B8}" type="datetimeFigureOut">
              <a:rPr lang="en-US" smtClean="0"/>
              <a:t>9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900363" y="857250"/>
            <a:ext cx="33432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FF821-4628-5A4A-91E6-CE9D8D258E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273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56649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9935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809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4741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1797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2638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1175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6671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6622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71148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0420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B1DD1-98E5-4B55-B549-8B2F59E61F45}" type="datetimeFigureOut">
              <a:rPr lang="en-GB" smtClean="0"/>
              <a:t>17/09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CB9B8-91B8-41C3-8BAB-1704A10193A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21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934"/>
          <a:stretch/>
        </p:blipFill>
        <p:spPr>
          <a:xfrm>
            <a:off x="3246954" y="576556"/>
            <a:ext cx="3086007" cy="248467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185"/>
          <a:stretch/>
        </p:blipFill>
        <p:spPr>
          <a:xfrm>
            <a:off x="6419404" y="574609"/>
            <a:ext cx="3364799" cy="2493985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589"/>
          <a:stretch/>
        </p:blipFill>
        <p:spPr>
          <a:xfrm>
            <a:off x="3246955" y="3117875"/>
            <a:ext cx="3086007" cy="226972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4698"/>
          <a:stretch/>
        </p:blipFill>
        <p:spPr>
          <a:xfrm>
            <a:off x="89855" y="3117875"/>
            <a:ext cx="3060550" cy="2260103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0959" y="192818"/>
            <a:ext cx="87357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Fibrosis: increasing stages within (A - C) and surrounding </a:t>
            </a:r>
            <a:r>
              <a:rPr lang="en-GB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M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deposits (D - E; fibrous encapsulation); and  F) Necrosis</a:t>
            </a:r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916"/>
          <a:stretch/>
        </p:blipFill>
        <p:spPr>
          <a:xfrm>
            <a:off x="91843" y="596122"/>
            <a:ext cx="3058562" cy="247402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7932414" y="5433270"/>
            <a:ext cx="86433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9855" y="5961252"/>
            <a:ext cx="9694347" cy="5693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: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Increasing stage of fibrosis: A) fine intercellular fibrosis (scale bar: 50µm); B)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ntratumoural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ibrous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septa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scale bar: 200µm); C) broad and bridging fibrosis creating small tumour ‘islands’ i.e.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rtumoural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ibrosis (scale bar: 100µm); D) &amp; E) fibrous encapsulation (scale bar: 2mm and 250µm, respectively); and F) coagulative tumour necrosis (scale bar: 500µm)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9855" y="5858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29762" y="5858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429510" y="60193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89855" y="311787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229762" y="311787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5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405" y="3117874"/>
            <a:ext cx="3364798" cy="2269725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7839281" y="4094800"/>
            <a:ext cx="34496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3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419103" y="312300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Straight Connector 2"/>
          <p:cNvCxnSpPr/>
          <p:nvPr/>
        </p:nvCxnSpPr>
        <p:spPr>
          <a:xfrm>
            <a:off x="192314" y="2983882"/>
            <a:ext cx="2120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877215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</TotalTime>
  <Words>116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mini krishna</dc:creator>
  <cp:lastModifiedBy>yamini krishna</cp:lastModifiedBy>
  <cp:revision>42</cp:revision>
  <dcterms:created xsi:type="dcterms:W3CDTF">2020-05-13T06:13:24Z</dcterms:created>
  <dcterms:modified xsi:type="dcterms:W3CDTF">2020-09-17T05:34:20Z</dcterms:modified>
</cp:coreProperties>
</file>